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50" d="100"/>
          <a:sy n="150" d="100"/>
        </p:scale>
        <p:origin x="-976" y="-8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CC0F23-BA2A-422A-84A6-9A83BABE1220}" type="datetimeFigureOut">
              <a:rPr lang="en-US" smtClean="0"/>
              <a:t>7/17/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DA5661-61B9-4E79-8B58-FCA78D08D2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7193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DA5661-61B9-4E79-8B58-FCA78D08D24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7460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18B9F-0165-441C-A70A-947C7C25EEE5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2989D-96B6-4E73-807E-4838E4A3A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0900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18B9F-0165-441C-A70A-947C7C25EEE5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2989D-96B6-4E73-807E-4838E4A3A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382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5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5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18B9F-0165-441C-A70A-947C7C25EEE5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2989D-96B6-4E73-807E-4838E4A3A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7290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18B9F-0165-441C-A70A-947C7C25EEE5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2989D-96B6-4E73-807E-4838E4A3A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6087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4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7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18B9F-0165-441C-A70A-947C7C25EEE5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2989D-96B6-4E73-807E-4838E4A3A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46139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18B9F-0165-441C-A70A-947C7C25EEE5}" type="datetimeFigureOut">
              <a:rPr lang="en-US" smtClean="0"/>
              <a:t>7/17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2989D-96B6-4E73-807E-4838E4A3A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8092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7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241552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2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18B9F-0165-441C-A70A-947C7C25EEE5}" type="datetimeFigureOut">
              <a:rPr lang="en-US" smtClean="0"/>
              <a:t>7/17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2989D-96B6-4E73-807E-4838E4A3A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45746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18B9F-0165-441C-A70A-947C7C25EEE5}" type="datetimeFigureOut">
              <a:rPr lang="en-US" smtClean="0"/>
              <a:t>7/17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2989D-96B6-4E73-807E-4838E4A3A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5128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18B9F-0165-441C-A70A-947C7C25EEE5}" type="datetimeFigureOut">
              <a:rPr lang="en-US" smtClean="0"/>
              <a:t>7/17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2989D-96B6-4E73-807E-4838E4A3A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45002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70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1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18B9F-0165-441C-A70A-947C7C25EEE5}" type="datetimeFigureOut">
              <a:rPr lang="en-US" smtClean="0"/>
              <a:t>7/17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2989D-96B6-4E73-807E-4838E4A3A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49969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70"/>
            <a:ext cx="3471863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1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18B9F-0165-441C-A70A-947C7C25EEE5}" type="datetimeFigureOut">
              <a:rPr lang="en-US" smtClean="0"/>
              <a:t>7/17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2989D-96B6-4E73-807E-4838E4A3A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84756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7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618B9F-0165-441C-A70A-947C7C25EEE5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7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D2989D-96B6-4E73-807E-4838E4A3A4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73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4" Type="http://schemas.openxmlformats.org/officeDocument/2006/relationships/image" Target="../media/image2.jp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696328" y="6370996"/>
            <a:ext cx="5289606" cy="51244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200" b="1" dirty="0" smtClean="0">
                <a:ea typeface="Calibri" panose="020F0502020204030204" pitchFamily="34" charset="0"/>
                <a:cs typeface="Times New Roman"/>
              </a:rPr>
              <a:t>Supplemental F</a:t>
            </a:r>
            <a:r>
              <a:rPr lang="en-US" sz="1200" b="1" dirty="0" smtClean="0">
                <a:ea typeface="Calibri" panose="020F0502020204030204" pitchFamily="34" charset="0"/>
                <a:cs typeface="Times New Roman"/>
              </a:rPr>
              <a:t>igure </a:t>
            </a:r>
            <a:r>
              <a:rPr lang="en-US" sz="1200" b="1" dirty="0" smtClean="0">
                <a:ea typeface="Calibri" panose="020F0502020204030204" pitchFamily="34" charset="0"/>
                <a:cs typeface="Times New Roman"/>
              </a:rPr>
              <a:t>S1</a:t>
            </a:r>
            <a:r>
              <a:rPr lang="en-US" sz="1200" dirty="0" smtClean="0">
                <a:ea typeface="Calibri" panose="020F0502020204030204" pitchFamily="34" charset="0"/>
                <a:cs typeface="Times New Roman"/>
              </a:rPr>
              <a:t>. </a:t>
            </a:r>
            <a:r>
              <a:rPr lang="en-US" sz="1200" dirty="0">
                <a:cs typeface="Times New Roman"/>
              </a:rPr>
              <a:t>The North Carolina isolates have the </a:t>
            </a:r>
            <a:r>
              <a:rPr lang="en-US" sz="1200" i="1" dirty="0">
                <a:cs typeface="Times New Roman"/>
              </a:rPr>
              <a:t>cfa7</a:t>
            </a:r>
            <a:r>
              <a:rPr lang="en-US" sz="1200" dirty="0">
                <a:cs typeface="Times New Roman"/>
              </a:rPr>
              <a:t> gene, which lies in the coronatine biosynthetic gene cluster. </a:t>
            </a:r>
            <a:endParaRPr lang="en-US" sz="1200" dirty="0">
              <a:effectLst/>
              <a:ea typeface="Calibri" panose="020F0502020204030204" pitchFamily="34" charset="0"/>
              <a:cs typeface="Times New Roman"/>
            </a:endParaRPr>
          </a:p>
        </p:txBody>
      </p:sp>
      <p:pic>
        <p:nvPicPr>
          <p:cNvPr id="41" name="Picture 4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2352" y="1288591"/>
            <a:ext cx="1622105" cy="4800600"/>
          </a:xfrm>
          <a:prstGeom prst="rect">
            <a:avLst/>
          </a:prstGeom>
        </p:spPr>
      </p:pic>
      <p:pic>
        <p:nvPicPr>
          <p:cNvPr id="42" name="Picture 4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6220" y="1285902"/>
            <a:ext cx="790279" cy="4800600"/>
          </a:xfrm>
          <a:prstGeom prst="rect">
            <a:avLst/>
          </a:prstGeom>
        </p:spPr>
      </p:pic>
      <p:sp>
        <p:nvSpPr>
          <p:cNvPr id="30" name="Right Arrow 29"/>
          <p:cNvSpPr/>
          <p:nvPr/>
        </p:nvSpPr>
        <p:spPr>
          <a:xfrm flipH="1">
            <a:off x="4662163" y="4314754"/>
            <a:ext cx="199982" cy="81991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Box 30"/>
          <p:cNvSpPr txBox="1"/>
          <p:nvPr/>
        </p:nvSpPr>
        <p:spPr>
          <a:xfrm>
            <a:off x="4835035" y="4128464"/>
            <a:ext cx="6733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fa7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1415589" y="3262698"/>
            <a:ext cx="8471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517 -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415589" y="3662808"/>
            <a:ext cx="8471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0 -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543829" y="4326391"/>
            <a:ext cx="71891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0 -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543829" y="5355091"/>
            <a:ext cx="71891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 -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 rot="16200000">
            <a:off x="2722765" y="1610159"/>
            <a:ext cx="1125679" cy="114390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dist">
              <a:spcAft>
                <a:spcPts val="500"/>
              </a:spcAft>
            </a:pPr>
            <a:r>
              <a:rPr lang="en-US" sz="2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C3000</a:t>
            </a:r>
          </a:p>
          <a:p>
            <a:pPr algn="dist">
              <a:spcAft>
                <a:spcPts val="500"/>
              </a:spcAft>
            </a:pPr>
            <a:r>
              <a:rPr lang="en-US" sz="2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3</a:t>
            </a:r>
          </a:p>
          <a:p>
            <a:pPr algn="dist">
              <a:spcAft>
                <a:spcPts val="500"/>
              </a:spcAft>
            </a:pPr>
            <a:r>
              <a:rPr lang="en-US" sz="2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201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2314919" y="2322759"/>
            <a:ext cx="3983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3854219" y="2310471"/>
            <a:ext cx="7970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-) </a:t>
            </a:r>
            <a:r>
              <a:rPr lang="en-US" sz="2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</a:t>
            </a:r>
            <a:endParaRPr lang="en-US" sz="2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592747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0</TotalTime>
  <Words>40</Words>
  <Application>Microsoft Macintosh PowerPoint</Application>
  <PresentationFormat>Letter Paper (8.5x11 in)</PresentationFormat>
  <Paragraphs>1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lu</dc:creator>
  <cp:lastModifiedBy>Gregory Martin</cp:lastModifiedBy>
  <cp:revision>18</cp:revision>
  <dcterms:created xsi:type="dcterms:W3CDTF">2014-07-05T17:14:00Z</dcterms:created>
  <dcterms:modified xsi:type="dcterms:W3CDTF">2014-07-17T14:58:23Z</dcterms:modified>
</cp:coreProperties>
</file>